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58" r:id="rId2"/>
  </p:sldIdLst>
  <p:sldSz cx="9144000" cy="6858000" type="screen4x3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99"/>
    <a:srgbClr val="FF3300"/>
    <a:srgbClr val="FFFF99"/>
    <a:srgbClr val="CC6600"/>
    <a:srgbClr val="0000FF"/>
    <a:srgbClr val="0000CC"/>
    <a:srgbClr val="80008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46" autoAdjust="0"/>
    <p:restoredTop sz="95627" autoAdjust="0"/>
  </p:normalViewPr>
  <p:slideViewPr>
    <p:cSldViewPr snapToGrid="0">
      <p:cViewPr varScale="1">
        <p:scale>
          <a:sx n="108" d="100"/>
          <a:sy n="108" d="100"/>
        </p:scale>
        <p:origin x="191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quarter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9EDB9036-A0C4-4B0A-A2DF-8A14D22382B7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2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3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CC95C0EA-AF05-437B-8E48-5682A51AA75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14655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D136F960-4483-4BB0-9C1C-198FAC25D0E5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47775" y="1279525"/>
            <a:ext cx="4603750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491" tIns="47745" rIns="95491" bIns="47745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709930" y="4925408"/>
            <a:ext cx="5679440" cy="4029879"/>
          </a:xfrm>
          <a:prstGeom prst="rect">
            <a:avLst/>
          </a:prstGeom>
        </p:spPr>
        <p:txBody>
          <a:bodyPr vert="horz" lIns="95491" tIns="47745" rIns="95491" bIns="47745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1BB30AF6-225D-4C3C-968F-215DC2620C9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9383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76927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00752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50285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19101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58359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2882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636365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44784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25207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30168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dirty="0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864401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39992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uadroTexto 10"/>
          <p:cNvSpPr txBox="1"/>
          <p:nvPr/>
        </p:nvSpPr>
        <p:spPr>
          <a:xfrm>
            <a:off x="6819900" y="6279095"/>
            <a:ext cx="2032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upo 11"/>
          <p:cNvGrpSpPr>
            <a:grpSpLocks noChangeAspect="1"/>
          </p:cNvGrpSpPr>
          <p:nvPr/>
        </p:nvGrpSpPr>
        <p:grpSpPr>
          <a:xfrm>
            <a:off x="2129595" y="1291668"/>
            <a:ext cx="4829913" cy="2805355"/>
            <a:chOff x="4253902" y="1407294"/>
            <a:chExt cx="4354749" cy="2529366"/>
          </a:xfrm>
        </p:grpSpPr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89" t="32201" r="31270" b="25218"/>
            <a:stretch/>
          </p:blipFill>
          <p:spPr>
            <a:xfrm>
              <a:off x="4253902" y="2677911"/>
              <a:ext cx="2118609" cy="1230923"/>
            </a:xfrm>
            <a:prstGeom prst="rect">
              <a:avLst/>
            </a:prstGeom>
          </p:spPr>
        </p:pic>
        <p:pic>
          <p:nvPicPr>
            <p:cNvPr id="13" name="6 Imagen"/>
            <p:cNvPicPr>
              <a:picLocks/>
            </p:cNvPicPr>
            <p:nvPr/>
          </p:nvPicPr>
          <p:blipFill rotWithShape="1">
            <a:blip r:embed="rId4" cstate="print">
              <a:duotone>
                <a:prstClr val="black"/>
                <a:schemeClr val="accent3">
                  <a:lumMod val="20000"/>
                  <a:lumOff val="80000"/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colorTemperature colorTemp="4700"/>
                      </a14:imgEffect>
                      <a14:imgEffect>
                        <a14:saturation sat="33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35" t="36056" r="31681" b="26586"/>
            <a:stretch/>
          </p:blipFill>
          <p:spPr>
            <a:xfrm>
              <a:off x="4253902" y="1407294"/>
              <a:ext cx="2118609" cy="1231200"/>
            </a:xfrm>
            <a:prstGeom prst="rect">
              <a:avLst/>
            </a:prstGeom>
          </p:spPr>
        </p:pic>
        <p:pic>
          <p:nvPicPr>
            <p:cNvPr id="3" name="Imagen 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750" t="31004" r="8942" b="33941"/>
            <a:stretch/>
          </p:blipFill>
          <p:spPr>
            <a:xfrm>
              <a:off x="6487541" y="2677910"/>
              <a:ext cx="2120400" cy="1230924"/>
            </a:xfrm>
            <a:prstGeom prst="rect">
              <a:avLst/>
            </a:prstGeom>
          </p:spPr>
        </p:pic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49" t="29753" r="8808" b="34818"/>
            <a:stretch/>
          </p:blipFill>
          <p:spPr>
            <a:xfrm>
              <a:off x="6486832" y="1407294"/>
              <a:ext cx="2121819" cy="1231200"/>
            </a:xfrm>
            <a:prstGeom prst="rect">
              <a:avLst/>
            </a:prstGeom>
          </p:spPr>
        </p:pic>
        <p:sp>
          <p:nvSpPr>
            <p:cNvPr id="9" name="CuadroTexto 8"/>
            <p:cNvSpPr txBox="1"/>
            <p:nvPr/>
          </p:nvSpPr>
          <p:spPr>
            <a:xfrm>
              <a:off x="4253902" y="2447627"/>
              <a:ext cx="7976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solidFill>
                    <a:srgbClr val="FFFF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RL 3631</a:t>
              </a:r>
              <a:endParaRPr lang="es-ES" sz="800" dirty="0">
                <a:solidFill>
                  <a:srgbClr val="FFFF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4253902" y="3721216"/>
              <a:ext cx="7976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solidFill>
                    <a:srgbClr val="FFFF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RL 3631</a:t>
              </a:r>
              <a:endParaRPr lang="es-ES" sz="800" dirty="0">
                <a:solidFill>
                  <a:srgbClr val="FFFF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6486832" y="3721216"/>
              <a:ext cx="7976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solidFill>
                    <a:srgbClr val="FFFF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S 277.49</a:t>
              </a:r>
              <a:endParaRPr lang="es-ES" sz="800" dirty="0">
                <a:solidFill>
                  <a:srgbClr val="FFFF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6486832" y="2447627"/>
              <a:ext cx="7976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solidFill>
                    <a:srgbClr val="FFFF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S 277.49</a:t>
              </a:r>
              <a:endParaRPr lang="es-ES" sz="800" dirty="0">
                <a:solidFill>
                  <a:srgbClr val="FFFF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ángulo 1"/>
          <p:cNvSpPr/>
          <p:nvPr/>
        </p:nvSpPr>
        <p:spPr>
          <a:xfrm>
            <a:off x="812186" y="4377489"/>
            <a:ext cx="771685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4.</a:t>
            </a:r>
            <a:r>
              <a:rPr lang="en-GB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croscopy observation of </a:t>
            </a:r>
            <a:r>
              <a:rPr lang="en-GB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rmlings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rown for 12 h in PDB of </a:t>
            </a:r>
            <a:r>
              <a:rPr lang="en-GB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. circinelloides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ld-type strains after DAPI staining of nuclei.</a:t>
            </a:r>
            <a:endParaRPr lang="es-E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743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73</TotalTime>
  <Words>36</Words>
  <Application>Microsoft Office PowerPoint</Application>
  <PresentationFormat>Presentación en pantalla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Universitat Rovira i Virgil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oida López Fernández</dc:creator>
  <cp:lastModifiedBy>Loida López Fernández</cp:lastModifiedBy>
  <cp:revision>318</cp:revision>
  <cp:lastPrinted>2017-12-05T12:24:16Z</cp:lastPrinted>
  <dcterms:created xsi:type="dcterms:W3CDTF">2016-05-12T10:16:36Z</dcterms:created>
  <dcterms:modified xsi:type="dcterms:W3CDTF">2017-12-05T19:29:54Z</dcterms:modified>
</cp:coreProperties>
</file>